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00440-D364-48E0-A9EA-FF470C7029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0D982-5D17-4E4D-AE2C-1B00B8498A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30E78-349B-49FB-A794-BBF6366E3E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23809-4227-4B50-9385-C0F8447BEA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AFA09-B375-40C5-9702-4B457AAED3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A2C55-967B-4F01-81BB-F1B3FCA152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84C53-0BD6-4DD1-9CFC-64E8193AE5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6DFB3-156A-4D04-8859-DE19EFF50F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BCDD3-6D55-4DB2-8696-DE67C06241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5450F-09AA-43CE-B698-22D151D1C4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B5E835-2CB8-4495-9973-BEF7966362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38A43-B072-440B-93EB-9D8ADC2A40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BB1962C-9572-4AAD-BD26-0BADF71B6271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5247F0D-4C1B-4B61-8FB4-E90F7B61F8C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3T15:28:23Z</dcterms:created>
  <dc:creator>a a</dc:creator>
  <dc:description/>
  <dc:language>en-US</dc:language>
  <cp:lastModifiedBy>a a</cp:lastModifiedBy>
  <dcterms:modified xsi:type="dcterms:W3CDTF">2012-12-08T14:36:06Z</dcterms:modified>
  <cp:revision>5</cp:revision>
  <dc:subject/>
  <dc:title>Slide 1</dc:title>
</cp:coreProperties>
</file>